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0" r:id="rId5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AFAF"/>
    <a:srgbClr val="FF9999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888" y="-90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9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9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9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64507" y="114517"/>
            <a:ext cx="7576987" cy="66289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extBox 2"/>
          <p:cNvSpPr txBox="1"/>
          <p:nvPr/>
        </p:nvSpPr>
        <p:spPr>
          <a:xfrm>
            <a:off x="0" y="0"/>
            <a:ext cx="3276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smtClean="0">
                <a:latin typeface="Arial" pitchFamily="34" charset="0"/>
                <a:cs typeface="Arial" pitchFamily="34" charset="0"/>
              </a:rPr>
              <a:t>Figure S1</a:t>
            </a:r>
            <a:endParaRPr lang="it-IT" sz="16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0"/>
            <a:ext cx="3276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smtClean="0">
                <a:latin typeface="Arial" pitchFamily="34" charset="0"/>
                <a:cs typeface="Arial" pitchFamily="34" charset="0"/>
              </a:rPr>
              <a:t>Figure S2</a:t>
            </a:r>
            <a:endParaRPr lang="it-IT" sz="1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64000" y="114074"/>
            <a:ext cx="7578000" cy="66298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/>
          <a:srcRect b="8889"/>
          <a:stretch>
            <a:fillRect/>
          </a:stretch>
        </p:blipFill>
        <p:spPr bwMode="auto">
          <a:xfrm>
            <a:off x="1524000" y="304800"/>
            <a:ext cx="6858000" cy="6248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extBox 2"/>
          <p:cNvSpPr txBox="1"/>
          <p:nvPr/>
        </p:nvSpPr>
        <p:spPr>
          <a:xfrm>
            <a:off x="0" y="0"/>
            <a:ext cx="3276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smtClean="0">
                <a:latin typeface="Arial" pitchFamily="34" charset="0"/>
                <a:cs typeface="Arial" pitchFamily="34" charset="0"/>
              </a:rPr>
              <a:t>Figure S3</a:t>
            </a:r>
            <a:endParaRPr lang="it-IT" sz="16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2890213" y="1397000"/>
          <a:ext cx="4125575" cy="4064000"/>
        </p:xfrm>
        <a:graphic>
          <a:graphicData uri="http://schemas.openxmlformats.org/drawingml/2006/table">
            <a:tbl>
              <a:tblPr/>
              <a:tblGrid>
                <a:gridCol w="825115"/>
                <a:gridCol w="825115"/>
                <a:gridCol w="825115"/>
                <a:gridCol w="825115"/>
                <a:gridCol w="825115"/>
              </a:tblGrid>
              <a:tr h="81280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1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GSE59590   </a:t>
                      </a:r>
                      <a:r>
                        <a:rPr lang="it-IT" sz="1200" b="1" i="0" u="none" strike="noStrike" dirty="0" smtClean="0">
                          <a:solidFill>
                            <a:srgbClr val="000000"/>
                          </a:solidFill>
                          <a:latin typeface="Arial"/>
                        </a:rPr>
                        <a:t>Milan</a:t>
                      </a:r>
                      <a:endParaRPr lang="it-IT" sz="1200" b="1" i="0" u="none" strike="noStrike" dirty="0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marL="9236" marR="9236" marT="92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4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0.525</a:t>
                      </a:r>
                    </a:p>
                  </a:txBody>
                  <a:tcPr marL="9236" marR="9236" marT="92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FCB7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4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0.006</a:t>
                      </a:r>
                    </a:p>
                  </a:txBody>
                  <a:tcPr marL="9236" marR="9236" marT="92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826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4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0.00001</a:t>
                      </a:r>
                    </a:p>
                  </a:txBody>
                  <a:tcPr marL="9236" marR="9236" marT="92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4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0.00012</a:t>
                      </a:r>
                    </a:p>
                  </a:txBody>
                  <a:tcPr marL="9236" marR="9236" marT="92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</a:tr>
              <a:tr h="81280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9236" marR="9236" marT="92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1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GSE2219      </a:t>
                      </a:r>
                      <a:r>
                        <a:rPr lang="it-IT" sz="1200" b="1" i="0" u="none" strike="noStrike" dirty="0" smtClean="0">
                          <a:solidFill>
                            <a:srgbClr val="000000"/>
                          </a:solidFill>
                          <a:latin typeface="Arial"/>
                        </a:rPr>
                        <a:t>Oxford</a:t>
                      </a:r>
                      <a:endParaRPr lang="it-IT" sz="1200" b="1" i="0" u="none" strike="noStrike" dirty="0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marL="9236" marR="9236" marT="92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4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0.056</a:t>
                      </a:r>
                    </a:p>
                  </a:txBody>
                  <a:tcPr marL="9236" marR="9236" marT="92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AFA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4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0.00004</a:t>
                      </a:r>
                    </a:p>
                  </a:txBody>
                  <a:tcPr marL="9236" marR="9236" marT="92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4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0.00057</a:t>
                      </a:r>
                    </a:p>
                  </a:txBody>
                  <a:tcPr marL="9236" marR="9236" marT="92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B6B"/>
                    </a:solidFill>
                  </a:tcPr>
                </a:tc>
              </a:tr>
              <a:tr h="81280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9236" marR="9236" marT="92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9236" marR="9236" marT="92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1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GSE59590 Shanghai</a:t>
                      </a:r>
                    </a:p>
                  </a:txBody>
                  <a:tcPr marL="9236" marR="9236" marT="92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4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0.284</a:t>
                      </a:r>
                    </a:p>
                  </a:txBody>
                  <a:tcPr marL="9236" marR="9236" marT="92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DB8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4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0.481</a:t>
                      </a:r>
                    </a:p>
                  </a:txBody>
                  <a:tcPr marL="9236" marR="9236" marT="92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CE7F"/>
                    </a:solidFill>
                  </a:tcPr>
                </a:tc>
              </a:tr>
              <a:tr h="81280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9236" marR="9236" marT="92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9236" marR="9236" marT="92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9236" marR="9236" marT="92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1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GSE48390 Taiwan</a:t>
                      </a:r>
                    </a:p>
                  </a:txBody>
                  <a:tcPr marL="9236" marR="9236" marT="92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4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0.714</a:t>
                      </a:r>
                    </a:p>
                  </a:txBody>
                  <a:tcPr marL="9236" marR="9236" marT="92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</a:tr>
              <a:tr h="81280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9236" marR="9236" marT="92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9236" marR="9236" marT="92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9236" marR="9236" marT="92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9236" marR="9236" marT="92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1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GSE36722 Singapore</a:t>
                      </a:r>
                    </a:p>
                  </a:txBody>
                  <a:tcPr marL="9236" marR="9236" marT="92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0" y="0"/>
            <a:ext cx="3276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smtClean="0">
                <a:latin typeface="Arial" pitchFamily="34" charset="0"/>
                <a:cs typeface="Arial" pitchFamily="34" charset="0"/>
              </a:rPr>
              <a:t>Figure S4</a:t>
            </a:r>
            <a:endParaRPr lang="it-IT" sz="16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8</TotalTime>
  <Words>28</Words>
  <Application>Microsoft Office PowerPoint</Application>
  <PresentationFormat>A4 Paper (210x297 mm)</PresentationFormat>
  <Paragraphs>29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Slide 2</vt:lpstr>
      <vt:lpstr>Slide 3</vt:lpstr>
      <vt:lpstr>Slide 4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/>
  <cp:lastModifiedBy>dugomatteo</cp:lastModifiedBy>
  <cp:revision>20</cp:revision>
  <dcterms:created xsi:type="dcterms:W3CDTF">2006-08-16T00:00:00Z</dcterms:created>
  <dcterms:modified xsi:type="dcterms:W3CDTF">2014-12-29T09:57:58Z</dcterms:modified>
</cp:coreProperties>
</file>